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>
        <p:scale>
          <a:sx n="125" d="100"/>
          <a:sy n="125" d="100"/>
        </p:scale>
        <p:origin x="-1397" y="-95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49A3CF2-D84F-42EB-9CE0-7DC9A3C6528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A3413091-4CE5-44BC-8DDD-428280F7709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AAA4437-B959-45DC-B1C3-C0EBCD4303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09F6D-2C91-464A-86B3-3BE204D62DDC}" type="datetimeFigureOut">
              <a:rPr lang="zh-CN" altLang="en-US" smtClean="0"/>
              <a:t>2023/3/9 Thursday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0D7C21A-F4B5-421B-866F-672E109A34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8C74471-B195-4B2F-8324-946E00335B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F5683-1054-4098-9EDE-1CB663B806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13060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9CCC3FB-8A3E-4433-AFAA-CA8032038D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7406F2A-BFA4-491D-9137-94B986FE4FA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D5548F4-6690-40A4-A829-B3823D34B6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09F6D-2C91-464A-86B3-3BE204D62DDC}" type="datetimeFigureOut">
              <a:rPr lang="zh-CN" altLang="en-US" smtClean="0"/>
              <a:t>2023/3/9 Thursday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E3C0F7E-4633-45ED-883D-0A1612E32A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72C493B-77D3-451D-A623-BD1CF785E1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F5683-1054-4098-9EDE-1CB663B806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21179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AEC847D7-09F9-4421-966F-49293F0FC48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EA7443A-1C74-4C28-9AEA-C3884C66F5D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0481890-E1C4-472C-ACFD-3B7F71C753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09F6D-2C91-464A-86B3-3BE204D62DDC}" type="datetimeFigureOut">
              <a:rPr lang="zh-CN" altLang="en-US" smtClean="0"/>
              <a:t>2023/3/9 Thursday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394E6DD-3093-4FBB-AB06-F20017E432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69C76A6-4BE1-419B-8518-639A0DDA8B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F5683-1054-4098-9EDE-1CB663B806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58734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A99C7E4-C059-440A-826C-991EDC94C3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49B93DB-5D5F-46FD-A65C-EE540938EBA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EC6EC23-8347-4490-BAEB-B2BD0D9BA8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09F6D-2C91-464A-86B3-3BE204D62DDC}" type="datetimeFigureOut">
              <a:rPr lang="zh-CN" altLang="en-US" smtClean="0"/>
              <a:t>2023/3/9 Thursday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C565D28-45F4-4EA1-8E4E-FEF0A9B0AA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8DE4CD7-CB11-40DD-8AAA-229DC0A25A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F5683-1054-4098-9EDE-1CB663B806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7220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31FD162-61E8-46A3-9062-AB3DCC01DB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B46C585-DC1B-4382-86FF-C1CB0B2987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885CB48-27F9-4040-BB00-EE8948AC40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09F6D-2C91-464A-86B3-3BE204D62DDC}" type="datetimeFigureOut">
              <a:rPr lang="zh-CN" altLang="en-US" smtClean="0"/>
              <a:t>2023/3/9 Thursday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F3665AF-0587-4629-90FA-475A545216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864A6A9-8CEB-4CC3-9BC7-E306EDE552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F5683-1054-4098-9EDE-1CB663B806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13381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B317868-FD2F-48FC-A67A-DF96EFBC09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B8D0485-749F-49AD-8EAE-CD8631E9E97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18F07A3-E915-4F20-A755-BBA033A264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A0456A7-0E44-4CBB-9EA9-300054E4DB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09F6D-2C91-464A-86B3-3BE204D62DDC}" type="datetimeFigureOut">
              <a:rPr lang="zh-CN" altLang="en-US" smtClean="0"/>
              <a:t>2023/3/9 Thursday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315884A-27ED-4B18-9E37-16D341585A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6A59D76-3108-40CB-8C3F-8D4DD11EBE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F5683-1054-4098-9EDE-1CB663B806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399182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35DC18D-417B-4F25-A206-060EF5C6E9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934E70B-EB65-4284-B327-0D3B13E89D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B65445C-07EA-4BCA-8734-B110DAB3091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44162484-41DF-4D12-912A-256F7A03B44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62A4AE75-B37A-43BD-9986-58FE4F5C517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310EC1B9-9B91-482E-9E1C-51A52A4521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09F6D-2C91-464A-86B3-3BE204D62DDC}" type="datetimeFigureOut">
              <a:rPr lang="zh-CN" altLang="en-US" smtClean="0"/>
              <a:t>2023/3/9 Thursday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D760CA2A-C6AA-498D-8637-60F4D1354D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AE893033-C84A-4913-A321-A1DD5A9DB2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F5683-1054-4098-9EDE-1CB663B806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731136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12A8657-80F5-42E3-9A3C-DA94DF11DC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B22BA162-7DF6-4960-AFC3-1FB3B8E887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09F6D-2C91-464A-86B3-3BE204D62DDC}" type="datetimeFigureOut">
              <a:rPr lang="zh-CN" altLang="en-US" smtClean="0"/>
              <a:t>2023/3/9 Thursday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EF1ADCB8-9E8E-41DC-92C5-AB5B6835FC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369BD761-9760-4D06-B8CA-7E2D7687C6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F5683-1054-4098-9EDE-1CB663B806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22512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52945CC3-3CA8-44CC-A2A9-B887778E92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09F6D-2C91-464A-86B3-3BE204D62DDC}" type="datetimeFigureOut">
              <a:rPr lang="zh-CN" altLang="en-US" smtClean="0"/>
              <a:t>2023/3/9 Thursday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E67A2A35-A493-44EA-826E-D4880EBE61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E3CE897B-00EE-4CE4-BB7D-EA3AC3456E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F5683-1054-4098-9EDE-1CB663B806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36440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7BC1153-FDFA-4251-9549-2F993D115B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E7399D8-67A9-489B-B925-353ADFCB6EF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AEFBD6B-64C6-41AD-A599-DC1D9326705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B650537-00F6-4AD9-81B2-DF0DFAAE69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09F6D-2C91-464A-86B3-3BE204D62DDC}" type="datetimeFigureOut">
              <a:rPr lang="zh-CN" altLang="en-US" smtClean="0"/>
              <a:t>2023/3/9 Thursday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962249D-5822-44B7-8B22-4FEEDD2515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861B7D5-7DA9-49B6-9497-70CEB2BF63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F5683-1054-4098-9EDE-1CB663B806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59827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018BF74-77A8-418C-A951-9C2C9B5417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D0921FE5-1739-4D31-BC08-7F8A53D4CFE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918CC4F-6520-42CE-B706-B7D83BDAFB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C95E463-ED9C-4720-9025-E1D8EFF52F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09F6D-2C91-464A-86B3-3BE204D62DDC}" type="datetimeFigureOut">
              <a:rPr lang="zh-CN" altLang="en-US" smtClean="0"/>
              <a:t>2023/3/9 Thursday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1232BD0-E5A7-4243-8D39-A01BA1F399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D27BC6B-7E78-448E-9128-C26A56A2A6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F5683-1054-4098-9EDE-1CB663B806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260513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41DEE8E7-3041-4FC9-920D-EDF14DD7F4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F490C8D-9DA4-4D0D-9D52-5AAE0337227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4BFFD2C-3B9E-4E5C-BFE4-647E739488F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F09F6D-2C91-464A-86B3-3BE204D62DDC}" type="datetimeFigureOut">
              <a:rPr lang="zh-CN" altLang="en-US" smtClean="0"/>
              <a:t>2023/3/9 Thursday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552F147-8484-46A7-9B25-772E3889648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99C83B1-C416-4B16-A8AD-02F197C7D35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4F5683-1054-4098-9EDE-1CB663B806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176542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png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3781426" y="2049516"/>
            <a:ext cx="4038271" cy="3247000"/>
            <a:chOff x="3781426" y="2049516"/>
            <a:chExt cx="4038271" cy="3247000"/>
          </a:xfrm>
        </p:grpSpPr>
        <p:grpSp>
          <p:nvGrpSpPr>
            <p:cNvPr id="1141" name="组合 1140">
              <a:extLst>
                <a:ext uri="{FF2B5EF4-FFF2-40B4-BE49-F238E27FC236}">
                  <a16:creationId xmlns:a16="http://schemas.microsoft.com/office/drawing/2014/main" id="{FEAB0365-2765-4A5D-8547-11CD5AB1F6D3}"/>
                </a:ext>
              </a:extLst>
            </p:cNvPr>
            <p:cNvGrpSpPr/>
            <p:nvPr/>
          </p:nvGrpSpPr>
          <p:grpSpPr>
            <a:xfrm>
              <a:off x="3781426" y="2049516"/>
              <a:ext cx="4038271" cy="3247000"/>
              <a:chOff x="3781426" y="1716088"/>
              <a:chExt cx="4371975" cy="3578225"/>
            </a:xfrm>
          </p:grpSpPr>
          <p:grpSp>
            <p:nvGrpSpPr>
              <p:cNvPr id="6" name="Group 4">
                <a:extLst>
                  <a:ext uri="{FF2B5EF4-FFF2-40B4-BE49-F238E27FC236}">
                    <a16:creationId xmlns:a16="http://schemas.microsoft.com/office/drawing/2014/main" id="{7CA7FA9E-A189-4C65-A459-1E1EC2638611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>
                <a:off x="3781426" y="1716088"/>
                <a:ext cx="4371975" cy="3578225"/>
                <a:chOff x="2382" y="1081"/>
                <a:chExt cx="2754" cy="2254"/>
              </a:xfrm>
            </p:grpSpPr>
            <p:sp>
              <p:nvSpPr>
                <p:cNvPr id="8" name="Rectangle 5">
                  <a:extLst>
                    <a:ext uri="{FF2B5EF4-FFF2-40B4-BE49-F238E27FC236}">
                      <a16:creationId xmlns:a16="http://schemas.microsoft.com/office/drawing/2014/main" id="{0E0E011C-D0F1-4129-908B-61DFCCF5EB0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94" y="1907"/>
                  <a:ext cx="288" cy="1114"/>
                </a:xfrm>
                <a:prstGeom prst="rect">
                  <a:avLst/>
                </a:prstGeom>
                <a:solidFill>
                  <a:srgbClr val="FC9898"/>
                </a:solidFill>
                <a:ln w="63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pic>
              <p:nvPicPr>
                <p:cNvPr id="1030" name="Picture 6">
                  <a:extLst>
                    <a:ext uri="{FF2B5EF4-FFF2-40B4-BE49-F238E27FC236}">
                      <a16:creationId xmlns:a16="http://schemas.microsoft.com/office/drawing/2014/main" id="{F449D4D8-BCCF-4101-9E20-781621E1A6D4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2" cstate="hq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894" y="1907"/>
                  <a:ext cx="288" cy="111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1031" name="Picture 7">
                  <a:extLst>
                    <a:ext uri="{FF2B5EF4-FFF2-40B4-BE49-F238E27FC236}">
                      <a16:creationId xmlns:a16="http://schemas.microsoft.com/office/drawing/2014/main" id="{A92C8CA3-E81D-43E5-9680-1D3346F527B9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3" cstate="hq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894" y="1907"/>
                  <a:ext cx="288" cy="111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9" name="Rectangle 8">
                  <a:extLst>
                    <a:ext uri="{FF2B5EF4-FFF2-40B4-BE49-F238E27FC236}">
                      <a16:creationId xmlns:a16="http://schemas.microsoft.com/office/drawing/2014/main" id="{A1B3B567-8DFD-46E8-9151-E4C481BA61B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94" y="1907"/>
                  <a:ext cx="288" cy="1114"/>
                </a:xfrm>
                <a:prstGeom prst="rect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" name="Rectangle 9">
                  <a:extLst>
                    <a:ext uri="{FF2B5EF4-FFF2-40B4-BE49-F238E27FC236}">
                      <a16:creationId xmlns:a16="http://schemas.microsoft.com/office/drawing/2014/main" id="{01F134D8-0E50-4170-9B8F-FF2D69A298D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70" y="2938"/>
                  <a:ext cx="288" cy="83"/>
                </a:xfrm>
                <a:prstGeom prst="rect">
                  <a:avLst/>
                </a:prstGeom>
                <a:solidFill>
                  <a:srgbClr val="FC9898"/>
                </a:solidFill>
                <a:ln w="63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pic>
              <p:nvPicPr>
                <p:cNvPr id="1034" name="Picture 10">
                  <a:extLst>
                    <a:ext uri="{FF2B5EF4-FFF2-40B4-BE49-F238E27FC236}">
                      <a16:creationId xmlns:a16="http://schemas.microsoft.com/office/drawing/2014/main" id="{E8079180-BE4D-499B-B74C-4A266D8E74FA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4" cstate="hq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470" y="2938"/>
                  <a:ext cx="288" cy="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1035" name="Picture 11">
                  <a:extLst>
                    <a:ext uri="{FF2B5EF4-FFF2-40B4-BE49-F238E27FC236}">
                      <a16:creationId xmlns:a16="http://schemas.microsoft.com/office/drawing/2014/main" id="{B89D1DDB-2443-4BC0-A597-19DD6D6E020C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5" cstate="hq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470" y="2938"/>
                  <a:ext cx="288" cy="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11" name="Rectangle 12">
                  <a:extLst>
                    <a:ext uri="{FF2B5EF4-FFF2-40B4-BE49-F238E27FC236}">
                      <a16:creationId xmlns:a16="http://schemas.microsoft.com/office/drawing/2014/main" id="{699DCB9D-D991-4DD4-986F-545E48FF16F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70" y="2938"/>
                  <a:ext cx="288" cy="83"/>
                </a:xfrm>
                <a:prstGeom prst="rect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2" name="Rectangle 13">
                  <a:extLst>
                    <a:ext uri="{FF2B5EF4-FFF2-40B4-BE49-F238E27FC236}">
                      <a16:creationId xmlns:a16="http://schemas.microsoft.com/office/drawing/2014/main" id="{ABC53F64-9C50-4BCF-8E23-24009F02E05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046" y="1401"/>
                  <a:ext cx="288" cy="1620"/>
                </a:xfrm>
                <a:prstGeom prst="rect">
                  <a:avLst/>
                </a:prstGeom>
                <a:solidFill>
                  <a:srgbClr val="FF0000"/>
                </a:solidFill>
                <a:ln w="63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pic>
              <p:nvPicPr>
                <p:cNvPr id="1038" name="Picture 14">
                  <a:extLst>
                    <a:ext uri="{FF2B5EF4-FFF2-40B4-BE49-F238E27FC236}">
                      <a16:creationId xmlns:a16="http://schemas.microsoft.com/office/drawing/2014/main" id="{46CEFD8D-A8DF-48D0-8C9A-E313E9BF1933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6" cstate="hq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046" y="1401"/>
                  <a:ext cx="288" cy="162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1039" name="Picture 15">
                  <a:extLst>
                    <a:ext uri="{FF2B5EF4-FFF2-40B4-BE49-F238E27FC236}">
                      <a16:creationId xmlns:a16="http://schemas.microsoft.com/office/drawing/2014/main" id="{EFDD8556-A2A6-48A2-9329-889E6AD02590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7" cstate="hq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046" y="1401"/>
                  <a:ext cx="288" cy="162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13" name="Rectangle 16">
                  <a:extLst>
                    <a:ext uri="{FF2B5EF4-FFF2-40B4-BE49-F238E27FC236}">
                      <a16:creationId xmlns:a16="http://schemas.microsoft.com/office/drawing/2014/main" id="{D414517F-1A02-40D8-AC15-ECA2E7212B6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046" y="1401"/>
                  <a:ext cx="288" cy="1620"/>
                </a:xfrm>
                <a:prstGeom prst="rect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4" name="Rectangle 17">
                  <a:extLst>
                    <a:ext uri="{FF2B5EF4-FFF2-40B4-BE49-F238E27FC236}">
                      <a16:creationId xmlns:a16="http://schemas.microsoft.com/office/drawing/2014/main" id="{44874657-9A77-473F-A3D4-5FA9AE49E7C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622" y="2977"/>
                  <a:ext cx="288" cy="44"/>
                </a:xfrm>
                <a:prstGeom prst="rect">
                  <a:avLst/>
                </a:prstGeom>
                <a:solidFill>
                  <a:srgbClr val="00FF00"/>
                </a:solidFill>
                <a:ln w="63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pic>
              <p:nvPicPr>
                <p:cNvPr id="1042" name="Picture 18">
                  <a:extLst>
                    <a:ext uri="{FF2B5EF4-FFF2-40B4-BE49-F238E27FC236}">
                      <a16:creationId xmlns:a16="http://schemas.microsoft.com/office/drawing/2014/main" id="{4390CF5E-DA3F-4DE7-AF47-A93DDD4FE6CD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8" cstate="hq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622" y="2977"/>
                  <a:ext cx="288" cy="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1043" name="Picture 19">
                  <a:extLst>
                    <a:ext uri="{FF2B5EF4-FFF2-40B4-BE49-F238E27FC236}">
                      <a16:creationId xmlns:a16="http://schemas.microsoft.com/office/drawing/2014/main" id="{9881CD38-8161-464E-8C66-55369343BE88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9" cstate="hq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622" y="2977"/>
                  <a:ext cx="288" cy="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15" name="Rectangle 20">
                  <a:extLst>
                    <a:ext uri="{FF2B5EF4-FFF2-40B4-BE49-F238E27FC236}">
                      <a16:creationId xmlns:a16="http://schemas.microsoft.com/office/drawing/2014/main" id="{07151AD1-D53A-46A4-A8C9-EA7414D651D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622" y="2977"/>
                  <a:ext cx="288" cy="44"/>
                </a:xfrm>
                <a:prstGeom prst="rect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6" name="Line 21">
                  <a:extLst>
                    <a:ext uri="{FF2B5EF4-FFF2-40B4-BE49-F238E27FC236}">
                      <a16:creationId xmlns:a16="http://schemas.microsoft.com/office/drawing/2014/main" id="{4E0A31B5-D505-4F56-AF2F-319B5ABD7CF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052" y="1932"/>
                  <a:ext cx="10" cy="18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7" name="Line 22">
                  <a:extLst>
                    <a:ext uri="{FF2B5EF4-FFF2-40B4-BE49-F238E27FC236}">
                      <a16:creationId xmlns:a16="http://schemas.microsoft.com/office/drawing/2014/main" id="{97D5BC51-C59A-4665-91E3-A611A2D3687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074" y="1971"/>
                  <a:ext cx="10" cy="18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8" name="Line 23">
                  <a:extLst>
                    <a:ext uri="{FF2B5EF4-FFF2-40B4-BE49-F238E27FC236}">
                      <a16:creationId xmlns:a16="http://schemas.microsoft.com/office/drawing/2014/main" id="{0D1E0508-3303-4391-8892-138247B15C1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095" y="2010"/>
                  <a:ext cx="11" cy="18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9" name="Line 24">
                  <a:extLst>
                    <a:ext uri="{FF2B5EF4-FFF2-40B4-BE49-F238E27FC236}">
                      <a16:creationId xmlns:a16="http://schemas.microsoft.com/office/drawing/2014/main" id="{B1A0BFF8-AAC9-45B3-AE78-CC2EB17395C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17" y="2049"/>
                  <a:ext cx="10" cy="18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20" name="Line 25">
                  <a:extLst>
                    <a:ext uri="{FF2B5EF4-FFF2-40B4-BE49-F238E27FC236}">
                      <a16:creationId xmlns:a16="http://schemas.microsoft.com/office/drawing/2014/main" id="{810401DA-FF33-4F96-8EC5-8D69BFB9CF7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39" y="2088"/>
                  <a:ext cx="10" cy="18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21" name="Line 26">
                  <a:extLst>
                    <a:ext uri="{FF2B5EF4-FFF2-40B4-BE49-F238E27FC236}">
                      <a16:creationId xmlns:a16="http://schemas.microsoft.com/office/drawing/2014/main" id="{F85B3656-C05A-403C-AB4F-ADBD2FA17D5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61" y="2127"/>
                  <a:ext cx="10" cy="18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22" name="Line 27">
                  <a:extLst>
                    <a:ext uri="{FF2B5EF4-FFF2-40B4-BE49-F238E27FC236}">
                      <a16:creationId xmlns:a16="http://schemas.microsoft.com/office/drawing/2014/main" id="{A0FA8E29-FB30-41CA-B543-0EA5C47D34E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82" y="2166"/>
                  <a:ext cx="11" cy="18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23" name="Line 28">
                  <a:extLst>
                    <a:ext uri="{FF2B5EF4-FFF2-40B4-BE49-F238E27FC236}">
                      <a16:creationId xmlns:a16="http://schemas.microsoft.com/office/drawing/2014/main" id="{15C272E0-B6FA-45ED-8DD8-9EBD417B2D4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204" y="2205"/>
                  <a:ext cx="11" cy="18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24" name="Line 29">
                  <a:extLst>
                    <a:ext uri="{FF2B5EF4-FFF2-40B4-BE49-F238E27FC236}">
                      <a16:creationId xmlns:a16="http://schemas.microsoft.com/office/drawing/2014/main" id="{BBA22806-38C0-4D11-B4F5-670A02B2858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226" y="2244"/>
                  <a:ext cx="10" cy="18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25" name="Line 30">
                  <a:extLst>
                    <a:ext uri="{FF2B5EF4-FFF2-40B4-BE49-F238E27FC236}">
                      <a16:creationId xmlns:a16="http://schemas.microsoft.com/office/drawing/2014/main" id="{AA43B88E-0705-45B5-BECC-EF84F517D10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248" y="2283"/>
                  <a:ext cx="10" cy="18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26" name="Line 31">
                  <a:extLst>
                    <a:ext uri="{FF2B5EF4-FFF2-40B4-BE49-F238E27FC236}">
                      <a16:creationId xmlns:a16="http://schemas.microsoft.com/office/drawing/2014/main" id="{BE2E98F0-979F-4CCB-BD09-A0A4FB56275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270" y="2322"/>
                  <a:ext cx="10" cy="19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27" name="Line 32">
                  <a:extLst>
                    <a:ext uri="{FF2B5EF4-FFF2-40B4-BE49-F238E27FC236}">
                      <a16:creationId xmlns:a16="http://schemas.microsoft.com/office/drawing/2014/main" id="{05CB930A-F904-44EB-BD1A-CF0D725A175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292" y="2361"/>
                  <a:ext cx="10" cy="18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28" name="Line 33">
                  <a:extLst>
                    <a:ext uri="{FF2B5EF4-FFF2-40B4-BE49-F238E27FC236}">
                      <a16:creationId xmlns:a16="http://schemas.microsoft.com/office/drawing/2014/main" id="{993B23A5-F782-45C3-9F02-3914A151D8D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313" y="2400"/>
                  <a:ext cx="11" cy="18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29" name="Line 34">
                  <a:extLst>
                    <a:ext uri="{FF2B5EF4-FFF2-40B4-BE49-F238E27FC236}">
                      <a16:creationId xmlns:a16="http://schemas.microsoft.com/office/drawing/2014/main" id="{7CCEEC02-57DD-484E-AF8F-C3EDA93E5A2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335" y="2439"/>
                  <a:ext cx="11" cy="19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0" name="Line 35">
                  <a:extLst>
                    <a:ext uri="{FF2B5EF4-FFF2-40B4-BE49-F238E27FC236}">
                      <a16:creationId xmlns:a16="http://schemas.microsoft.com/office/drawing/2014/main" id="{31759AB5-74C6-4A31-BCF3-5215928DB86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357" y="2478"/>
                  <a:ext cx="10" cy="18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1" name="Line 36">
                  <a:extLst>
                    <a:ext uri="{FF2B5EF4-FFF2-40B4-BE49-F238E27FC236}">
                      <a16:creationId xmlns:a16="http://schemas.microsoft.com/office/drawing/2014/main" id="{874005F6-B631-4D1B-BFFE-82A110F22C4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379" y="2517"/>
                  <a:ext cx="10" cy="18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2" name="Line 37">
                  <a:extLst>
                    <a:ext uri="{FF2B5EF4-FFF2-40B4-BE49-F238E27FC236}">
                      <a16:creationId xmlns:a16="http://schemas.microsoft.com/office/drawing/2014/main" id="{AC4A4268-5012-4801-810F-2096F77F43A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401" y="2556"/>
                  <a:ext cx="10" cy="19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3" name="Line 38">
                  <a:extLst>
                    <a:ext uri="{FF2B5EF4-FFF2-40B4-BE49-F238E27FC236}">
                      <a16:creationId xmlns:a16="http://schemas.microsoft.com/office/drawing/2014/main" id="{2255CB5A-C4B6-438D-8308-18C3B14113F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422" y="2595"/>
                  <a:ext cx="11" cy="19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4" name="Line 39">
                  <a:extLst>
                    <a:ext uri="{FF2B5EF4-FFF2-40B4-BE49-F238E27FC236}">
                      <a16:creationId xmlns:a16="http://schemas.microsoft.com/office/drawing/2014/main" id="{92CCE627-0C5E-43C7-BD88-B89943E8AA1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444" y="2634"/>
                  <a:ext cx="10" cy="18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5" name="Line 40">
                  <a:extLst>
                    <a:ext uri="{FF2B5EF4-FFF2-40B4-BE49-F238E27FC236}">
                      <a16:creationId xmlns:a16="http://schemas.microsoft.com/office/drawing/2014/main" id="{67988935-BAE9-4B48-8788-68624235FBF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467" y="2673"/>
                  <a:ext cx="10" cy="19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6" name="Line 41">
                  <a:extLst>
                    <a:ext uri="{FF2B5EF4-FFF2-40B4-BE49-F238E27FC236}">
                      <a16:creationId xmlns:a16="http://schemas.microsoft.com/office/drawing/2014/main" id="{4F64D02F-FBF9-4EE1-BC13-BDB5C4184BF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488" y="2712"/>
                  <a:ext cx="11" cy="19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7" name="Line 42">
                  <a:extLst>
                    <a:ext uri="{FF2B5EF4-FFF2-40B4-BE49-F238E27FC236}">
                      <a16:creationId xmlns:a16="http://schemas.microsoft.com/office/drawing/2014/main" id="{EC1C5C70-6BF2-479A-AED0-32255E10DDE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510" y="2751"/>
                  <a:ext cx="10" cy="19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8" name="Line 43">
                  <a:extLst>
                    <a:ext uri="{FF2B5EF4-FFF2-40B4-BE49-F238E27FC236}">
                      <a16:creationId xmlns:a16="http://schemas.microsoft.com/office/drawing/2014/main" id="{1179D7EB-0C55-4741-876A-4D9A4843F82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532" y="2791"/>
                  <a:ext cx="10" cy="18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9" name="Line 44">
                  <a:extLst>
                    <a:ext uri="{FF2B5EF4-FFF2-40B4-BE49-F238E27FC236}">
                      <a16:creationId xmlns:a16="http://schemas.microsoft.com/office/drawing/2014/main" id="{C367D6FB-F86D-4D71-B48D-90F9E3BE7DB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554" y="2829"/>
                  <a:ext cx="10" cy="19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40" name="Line 45">
                  <a:extLst>
                    <a:ext uri="{FF2B5EF4-FFF2-40B4-BE49-F238E27FC236}">
                      <a16:creationId xmlns:a16="http://schemas.microsoft.com/office/drawing/2014/main" id="{B1795520-6B71-4B9F-9730-DA0AD968874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575" y="2868"/>
                  <a:ext cx="10" cy="19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41" name="Line 46">
                  <a:extLst>
                    <a:ext uri="{FF2B5EF4-FFF2-40B4-BE49-F238E27FC236}">
                      <a16:creationId xmlns:a16="http://schemas.microsoft.com/office/drawing/2014/main" id="{758A2C27-473F-4BB1-83FC-64B40D1D332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597" y="2908"/>
                  <a:ext cx="3" cy="5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42" name="Line 47">
                  <a:extLst>
                    <a:ext uri="{FF2B5EF4-FFF2-40B4-BE49-F238E27FC236}">
                      <a16:creationId xmlns:a16="http://schemas.microsoft.com/office/drawing/2014/main" id="{D0C1EEAF-A1B3-45ED-9D71-E38513AB01A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 flipV="1">
                  <a:off x="3597" y="2908"/>
                  <a:ext cx="3" cy="5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43" name="Line 48">
                  <a:extLst>
                    <a:ext uri="{FF2B5EF4-FFF2-40B4-BE49-F238E27FC236}">
                      <a16:creationId xmlns:a16="http://schemas.microsoft.com/office/drawing/2014/main" id="{26AD367E-A09E-4BDE-8782-C0B4276B8EA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624" y="2891"/>
                  <a:ext cx="7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44" name="Line 49">
                  <a:extLst>
                    <a:ext uri="{FF2B5EF4-FFF2-40B4-BE49-F238E27FC236}">
                      <a16:creationId xmlns:a16="http://schemas.microsoft.com/office/drawing/2014/main" id="{88C08A0F-96D6-4EE1-A0C9-6FC0921595E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640" y="2849"/>
                  <a:ext cx="7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45" name="Line 50">
                  <a:extLst>
                    <a:ext uri="{FF2B5EF4-FFF2-40B4-BE49-F238E27FC236}">
                      <a16:creationId xmlns:a16="http://schemas.microsoft.com/office/drawing/2014/main" id="{9EE06313-5556-4FBB-B36A-91C66C08C2D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656" y="2808"/>
                  <a:ext cx="7" cy="19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46" name="Line 51">
                  <a:extLst>
                    <a:ext uri="{FF2B5EF4-FFF2-40B4-BE49-F238E27FC236}">
                      <a16:creationId xmlns:a16="http://schemas.microsoft.com/office/drawing/2014/main" id="{8FF2897C-A0F8-455C-BF33-EDF01BF048B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671" y="2766"/>
                  <a:ext cx="8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47" name="Line 52">
                  <a:extLst>
                    <a:ext uri="{FF2B5EF4-FFF2-40B4-BE49-F238E27FC236}">
                      <a16:creationId xmlns:a16="http://schemas.microsoft.com/office/drawing/2014/main" id="{29B16165-C627-4BAA-9D8B-924BD18A675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687" y="2724"/>
                  <a:ext cx="7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48" name="Line 53">
                  <a:extLst>
                    <a:ext uri="{FF2B5EF4-FFF2-40B4-BE49-F238E27FC236}">
                      <a16:creationId xmlns:a16="http://schemas.microsoft.com/office/drawing/2014/main" id="{3FB1E3CF-3964-4D66-B65B-C13D5654E4F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703" y="2682"/>
                  <a:ext cx="7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49" name="Line 54">
                  <a:extLst>
                    <a:ext uri="{FF2B5EF4-FFF2-40B4-BE49-F238E27FC236}">
                      <a16:creationId xmlns:a16="http://schemas.microsoft.com/office/drawing/2014/main" id="{7E31F28E-A9F5-4C09-BFD0-AE671BAA38B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718" y="2640"/>
                  <a:ext cx="7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50" name="Line 55">
                  <a:extLst>
                    <a:ext uri="{FF2B5EF4-FFF2-40B4-BE49-F238E27FC236}">
                      <a16:creationId xmlns:a16="http://schemas.microsoft.com/office/drawing/2014/main" id="{3EAA1503-30FE-40F1-BF90-D6FCB87B0BB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734" y="2598"/>
                  <a:ext cx="7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51" name="Line 56">
                  <a:extLst>
                    <a:ext uri="{FF2B5EF4-FFF2-40B4-BE49-F238E27FC236}">
                      <a16:creationId xmlns:a16="http://schemas.microsoft.com/office/drawing/2014/main" id="{AB630428-34B0-4FA1-8FC8-BF8F9FE973D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750" y="2557"/>
                  <a:ext cx="7" cy="19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52" name="Line 57">
                  <a:extLst>
                    <a:ext uri="{FF2B5EF4-FFF2-40B4-BE49-F238E27FC236}">
                      <a16:creationId xmlns:a16="http://schemas.microsoft.com/office/drawing/2014/main" id="{D67D4100-A40F-4DD4-8068-4D7019761D9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765" y="2515"/>
                  <a:ext cx="8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53" name="Line 58">
                  <a:extLst>
                    <a:ext uri="{FF2B5EF4-FFF2-40B4-BE49-F238E27FC236}">
                      <a16:creationId xmlns:a16="http://schemas.microsoft.com/office/drawing/2014/main" id="{B6E702F2-3907-40F5-B7A4-C3899B35493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781" y="2473"/>
                  <a:ext cx="8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54" name="Line 59">
                  <a:extLst>
                    <a:ext uri="{FF2B5EF4-FFF2-40B4-BE49-F238E27FC236}">
                      <a16:creationId xmlns:a16="http://schemas.microsoft.com/office/drawing/2014/main" id="{A344978E-3691-4A4A-8503-6A6DD432E41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797" y="2431"/>
                  <a:ext cx="7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55" name="Line 60">
                  <a:extLst>
                    <a:ext uri="{FF2B5EF4-FFF2-40B4-BE49-F238E27FC236}">
                      <a16:creationId xmlns:a16="http://schemas.microsoft.com/office/drawing/2014/main" id="{ADDB41A7-A8CE-4A9A-8F94-DE00D779318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812" y="2389"/>
                  <a:ext cx="8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56" name="Line 61">
                  <a:extLst>
                    <a:ext uri="{FF2B5EF4-FFF2-40B4-BE49-F238E27FC236}">
                      <a16:creationId xmlns:a16="http://schemas.microsoft.com/office/drawing/2014/main" id="{376C831B-89DA-45AD-ADC8-D9B3D6A74E7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828" y="2347"/>
                  <a:ext cx="7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57" name="Line 62">
                  <a:extLst>
                    <a:ext uri="{FF2B5EF4-FFF2-40B4-BE49-F238E27FC236}">
                      <a16:creationId xmlns:a16="http://schemas.microsoft.com/office/drawing/2014/main" id="{7CA3051B-A9E4-4631-BA94-B835664BDDA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844" y="2306"/>
                  <a:ext cx="7" cy="19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58" name="Line 63">
                  <a:extLst>
                    <a:ext uri="{FF2B5EF4-FFF2-40B4-BE49-F238E27FC236}">
                      <a16:creationId xmlns:a16="http://schemas.microsoft.com/office/drawing/2014/main" id="{A95CE753-D084-42E1-9583-A044A4520F1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859" y="2264"/>
                  <a:ext cx="8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59" name="Line 64">
                  <a:extLst>
                    <a:ext uri="{FF2B5EF4-FFF2-40B4-BE49-F238E27FC236}">
                      <a16:creationId xmlns:a16="http://schemas.microsoft.com/office/drawing/2014/main" id="{AB5B2DDD-28F2-4C6D-8C5B-C2A625E35A6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875" y="2222"/>
                  <a:ext cx="8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60" name="Line 65">
                  <a:extLst>
                    <a:ext uri="{FF2B5EF4-FFF2-40B4-BE49-F238E27FC236}">
                      <a16:creationId xmlns:a16="http://schemas.microsoft.com/office/drawing/2014/main" id="{11E5C639-6FF4-4859-9B03-7264CDB9923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891" y="2180"/>
                  <a:ext cx="7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61" name="Line 66">
                  <a:extLst>
                    <a:ext uri="{FF2B5EF4-FFF2-40B4-BE49-F238E27FC236}">
                      <a16:creationId xmlns:a16="http://schemas.microsoft.com/office/drawing/2014/main" id="{6227EDEC-5195-42FF-AF5B-AC740258EEC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906" y="2138"/>
                  <a:ext cx="8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62" name="Line 67">
                  <a:extLst>
                    <a:ext uri="{FF2B5EF4-FFF2-40B4-BE49-F238E27FC236}">
                      <a16:creationId xmlns:a16="http://schemas.microsoft.com/office/drawing/2014/main" id="{6A64DAB9-027A-4624-BF47-0AECD3B1840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922" y="2097"/>
                  <a:ext cx="7" cy="19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63" name="Line 68">
                  <a:extLst>
                    <a:ext uri="{FF2B5EF4-FFF2-40B4-BE49-F238E27FC236}">
                      <a16:creationId xmlns:a16="http://schemas.microsoft.com/office/drawing/2014/main" id="{FE0F1F2E-976C-41E2-8F4B-4B12A095587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938" y="2055"/>
                  <a:ext cx="7" cy="19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24" name="Line 69">
                  <a:extLst>
                    <a:ext uri="{FF2B5EF4-FFF2-40B4-BE49-F238E27FC236}">
                      <a16:creationId xmlns:a16="http://schemas.microsoft.com/office/drawing/2014/main" id="{A1CBA36A-375D-4937-8F68-9ABE03A831D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953" y="2013"/>
                  <a:ext cx="8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25" name="Line 70">
                  <a:extLst>
                    <a:ext uri="{FF2B5EF4-FFF2-40B4-BE49-F238E27FC236}">
                      <a16:creationId xmlns:a16="http://schemas.microsoft.com/office/drawing/2014/main" id="{467236BF-67D8-4C53-9DA1-F32E5A36F17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969" y="1971"/>
                  <a:ext cx="8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26" name="Line 71">
                  <a:extLst>
                    <a:ext uri="{FF2B5EF4-FFF2-40B4-BE49-F238E27FC236}">
                      <a16:creationId xmlns:a16="http://schemas.microsoft.com/office/drawing/2014/main" id="{D18F280F-E547-4DDF-8CA8-B39A1D92205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985" y="1929"/>
                  <a:ext cx="7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27" name="Line 72">
                  <a:extLst>
                    <a:ext uri="{FF2B5EF4-FFF2-40B4-BE49-F238E27FC236}">
                      <a16:creationId xmlns:a16="http://schemas.microsoft.com/office/drawing/2014/main" id="{210DD345-6F53-4B93-9B2A-8B66BAAAA45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000" y="1887"/>
                  <a:ext cx="8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28" name="Line 73">
                  <a:extLst>
                    <a:ext uri="{FF2B5EF4-FFF2-40B4-BE49-F238E27FC236}">
                      <a16:creationId xmlns:a16="http://schemas.microsoft.com/office/drawing/2014/main" id="{4E8ACD5B-4CBB-47F9-B0D6-E253CBE4A65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016" y="1846"/>
                  <a:ext cx="7" cy="19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29" name="Line 74">
                  <a:extLst>
                    <a:ext uri="{FF2B5EF4-FFF2-40B4-BE49-F238E27FC236}">
                      <a16:creationId xmlns:a16="http://schemas.microsoft.com/office/drawing/2014/main" id="{A7FD5C34-A43D-475D-84D9-312BB86D816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032" y="1804"/>
                  <a:ext cx="7" cy="19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32" name="Line 75">
                  <a:extLst>
                    <a:ext uri="{FF2B5EF4-FFF2-40B4-BE49-F238E27FC236}">
                      <a16:creationId xmlns:a16="http://schemas.microsoft.com/office/drawing/2014/main" id="{EE80DEC0-214B-40B9-8E90-8598C2319F3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047" y="1762"/>
                  <a:ext cx="8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33" name="Line 76">
                  <a:extLst>
                    <a:ext uri="{FF2B5EF4-FFF2-40B4-BE49-F238E27FC236}">
                      <a16:creationId xmlns:a16="http://schemas.microsoft.com/office/drawing/2014/main" id="{FF29A87B-9C01-4570-9749-B8D82091533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063" y="1720"/>
                  <a:ext cx="8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36" name="Line 77">
                  <a:extLst>
                    <a:ext uri="{FF2B5EF4-FFF2-40B4-BE49-F238E27FC236}">
                      <a16:creationId xmlns:a16="http://schemas.microsoft.com/office/drawing/2014/main" id="{70198792-BD47-4AD1-AFC9-88874D5F9E9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079" y="1678"/>
                  <a:ext cx="7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37" name="Line 78">
                  <a:extLst>
                    <a:ext uri="{FF2B5EF4-FFF2-40B4-BE49-F238E27FC236}">
                      <a16:creationId xmlns:a16="http://schemas.microsoft.com/office/drawing/2014/main" id="{021075E2-3A26-46A7-9360-E45E47DA6DD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095" y="1636"/>
                  <a:ext cx="7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40" name="Line 79">
                  <a:extLst>
                    <a:ext uri="{FF2B5EF4-FFF2-40B4-BE49-F238E27FC236}">
                      <a16:creationId xmlns:a16="http://schemas.microsoft.com/office/drawing/2014/main" id="{DD92E855-F268-450B-A1B8-01251EF26D6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110" y="1595"/>
                  <a:ext cx="7" cy="19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41" name="Line 80">
                  <a:extLst>
                    <a:ext uri="{FF2B5EF4-FFF2-40B4-BE49-F238E27FC236}">
                      <a16:creationId xmlns:a16="http://schemas.microsoft.com/office/drawing/2014/main" id="{639F738B-312D-4AB5-B803-E21823B5A7E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126" y="1553"/>
                  <a:ext cx="7" cy="19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44" name="Line 81">
                  <a:extLst>
                    <a:ext uri="{FF2B5EF4-FFF2-40B4-BE49-F238E27FC236}">
                      <a16:creationId xmlns:a16="http://schemas.microsoft.com/office/drawing/2014/main" id="{53DB2FDC-577E-48E2-89B8-97114D251BF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141" y="1511"/>
                  <a:ext cx="8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45" name="Line 82">
                  <a:extLst>
                    <a:ext uri="{FF2B5EF4-FFF2-40B4-BE49-F238E27FC236}">
                      <a16:creationId xmlns:a16="http://schemas.microsoft.com/office/drawing/2014/main" id="{8BF6AAAC-B020-4166-8509-6D281B1B31D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157" y="1469"/>
                  <a:ext cx="8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46" name="Line 83">
                  <a:extLst>
                    <a:ext uri="{FF2B5EF4-FFF2-40B4-BE49-F238E27FC236}">
                      <a16:creationId xmlns:a16="http://schemas.microsoft.com/office/drawing/2014/main" id="{60347C61-45A7-447A-91F8-3958408E8E1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173" y="1427"/>
                  <a:ext cx="7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47" name="Line 84">
                  <a:extLst>
                    <a:ext uri="{FF2B5EF4-FFF2-40B4-BE49-F238E27FC236}">
                      <a16:creationId xmlns:a16="http://schemas.microsoft.com/office/drawing/2014/main" id="{AF42E023-D49D-4D26-B5BA-7EE157C596D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173" y="1427"/>
                  <a:ext cx="7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48" name="Line 85">
                  <a:extLst>
                    <a:ext uri="{FF2B5EF4-FFF2-40B4-BE49-F238E27FC236}">
                      <a16:creationId xmlns:a16="http://schemas.microsoft.com/office/drawing/2014/main" id="{31DA3D5F-AFE9-498B-BC4F-8C8AE5A0255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200" y="1427"/>
                  <a:ext cx="8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49" name="Line 86">
                  <a:extLst>
                    <a:ext uri="{FF2B5EF4-FFF2-40B4-BE49-F238E27FC236}">
                      <a16:creationId xmlns:a16="http://schemas.microsoft.com/office/drawing/2014/main" id="{335462ED-BE39-4A44-9BCB-3CFEEDE4CC2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216" y="1469"/>
                  <a:ext cx="7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50" name="Line 87">
                  <a:extLst>
                    <a:ext uri="{FF2B5EF4-FFF2-40B4-BE49-F238E27FC236}">
                      <a16:creationId xmlns:a16="http://schemas.microsoft.com/office/drawing/2014/main" id="{7E21D08C-D964-4A81-AA03-29E6DB06346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231" y="1511"/>
                  <a:ext cx="7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51" name="Line 88">
                  <a:extLst>
                    <a:ext uri="{FF2B5EF4-FFF2-40B4-BE49-F238E27FC236}">
                      <a16:creationId xmlns:a16="http://schemas.microsoft.com/office/drawing/2014/main" id="{E140D95A-5A8A-42B5-9459-A8A0DDEB498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247" y="1553"/>
                  <a:ext cx="7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52" name="Line 89">
                  <a:extLst>
                    <a:ext uri="{FF2B5EF4-FFF2-40B4-BE49-F238E27FC236}">
                      <a16:creationId xmlns:a16="http://schemas.microsoft.com/office/drawing/2014/main" id="{2E4D9528-AB2F-47CB-B1DD-79130FE8E51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262" y="1595"/>
                  <a:ext cx="7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53" name="Line 90">
                  <a:extLst>
                    <a:ext uri="{FF2B5EF4-FFF2-40B4-BE49-F238E27FC236}">
                      <a16:creationId xmlns:a16="http://schemas.microsoft.com/office/drawing/2014/main" id="{9EB529F8-5A9D-436B-ABD9-99EFEAD7FB8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277" y="1637"/>
                  <a:ext cx="7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54" name="Line 91">
                  <a:extLst>
                    <a:ext uri="{FF2B5EF4-FFF2-40B4-BE49-F238E27FC236}">
                      <a16:creationId xmlns:a16="http://schemas.microsoft.com/office/drawing/2014/main" id="{45E992D6-FBA5-4F4D-8539-12D7677DEDF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292" y="1679"/>
                  <a:ext cx="8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55" name="Line 92">
                  <a:extLst>
                    <a:ext uri="{FF2B5EF4-FFF2-40B4-BE49-F238E27FC236}">
                      <a16:creationId xmlns:a16="http://schemas.microsoft.com/office/drawing/2014/main" id="{894C0654-C15F-424C-97C5-E2DD372B037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307" y="1721"/>
                  <a:ext cx="8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56" name="Line 93">
                  <a:extLst>
                    <a:ext uri="{FF2B5EF4-FFF2-40B4-BE49-F238E27FC236}">
                      <a16:creationId xmlns:a16="http://schemas.microsoft.com/office/drawing/2014/main" id="{ACBF1987-E6BE-4685-8D0A-C5E3D1D4F93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323" y="1763"/>
                  <a:ext cx="7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57" name="Line 94">
                  <a:extLst>
                    <a:ext uri="{FF2B5EF4-FFF2-40B4-BE49-F238E27FC236}">
                      <a16:creationId xmlns:a16="http://schemas.microsoft.com/office/drawing/2014/main" id="{7F560A11-FAE9-46B2-B3E4-47A5D1B6A53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338" y="1805"/>
                  <a:ext cx="7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58" name="Line 95">
                  <a:extLst>
                    <a:ext uri="{FF2B5EF4-FFF2-40B4-BE49-F238E27FC236}">
                      <a16:creationId xmlns:a16="http://schemas.microsoft.com/office/drawing/2014/main" id="{6B63B868-67F9-49D7-B91F-A927BADAF06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354" y="1847"/>
                  <a:ext cx="7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59" name="Line 96">
                  <a:extLst>
                    <a:ext uri="{FF2B5EF4-FFF2-40B4-BE49-F238E27FC236}">
                      <a16:creationId xmlns:a16="http://schemas.microsoft.com/office/drawing/2014/main" id="{32344445-066E-4A8C-9A65-8B2A6035164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369" y="1889"/>
                  <a:ext cx="7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60" name="Line 97">
                  <a:extLst>
                    <a:ext uri="{FF2B5EF4-FFF2-40B4-BE49-F238E27FC236}">
                      <a16:creationId xmlns:a16="http://schemas.microsoft.com/office/drawing/2014/main" id="{B01C62A4-4089-4166-9754-C85AF045F2B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384" y="1931"/>
                  <a:ext cx="7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61" name="Line 98">
                  <a:extLst>
                    <a:ext uri="{FF2B5EF4-FFF2-40B4-BE49-F238E27FC236}">
                      <a16:creationId xmlns:a16="http://schemas.microsoft.com/office/drawing/2014/main" id="{EE854F73-ED11-4DDD-91D0-94D93DD09E8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399" y="1973"/>
                  <a:ext cx="8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62" name="Line 99">
                  <a:extLst>
                    <a:ext uri="{FF2B5EF4-FFF2-40B4-BE49-F238E27FC236}">
                      <a16:creationId xmlns:a16="http://schemas.microsoft.com/office/drawing/2014/main" id="{39DE86EB-5F74-4B60-A0CD-9749454AC0C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415" y="2015"/>
                  <a:ext cx="7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63" name="Line 100">
                  <a:extLst>
                    <a:ext uri="{FF2B5EF4-FFF2-40B4-BE49-F238E27FC236}">
                      <a16:creationId xmlns:a16="http://schemas.microsoft.com/office/drawing/2014/main" id="{3BAD2651-2BE2-407B-9C06-B75D6027F1D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430" y="2057"/>
                  <a:ext cx="8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64" name="Line 101">
                  <a:extLst>
                    <a:ext uri="{FF2B5EF4-FFF2-40B4-BE49-F238E27FC236}">
                      <a16:creationId xmlns:a16="http://schemas.microsoft.com/office/drawing/2014/main" id="{0D932AF3-8796-4E34-85EA-0AFA44F5ED0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446" y="2099"/>
                  <a:ext cx="7" cy="19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65" name="Line 102">
                  <a:extLst>
                    <a:ext uri="{FF2B5EF4-FFF2-40B4-BE49-F238E27FC236}">
                      <a16:creationId xmlns:a16="http://schemas.microsoft.com/office/drawing/2014/main" id="{75FE8B7B-9323-435F-85E6-1D39B4D6C91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461" y="2141"/>
                  <a:ext cx="7" cy="19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66" name="Line 103">
                  <a:extLst>
                    <a:ext uri="{FF2B5EF4-FFF2-40B4-BE49-F238E27FC236}">
                      <a16:creationId xmlns:a16="http://schemas.microsoft.com/office/drawing/2014/main" id="{20BC63A5-E325-46BF-B8DE-4BEFCC9A287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476" y="2183"/>
                  <a:ext cx="7" cy="19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67" name="Line 104">
                  <a:extLst>
                    <a:ext uri="{FF2B5EF4-FFF2-40B4-BE49-F238E27FC236}">
                      <a16:creationId xmlns:a16="http://schemas.microsoft.com/office/drawing/2014/main" id="{95FE3D7E-1E19-4E77-92FD-BDD68F8835C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492" y="2225"/>
                  <a:ext cx="7" cy="19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68" name="Line 105">
                  <a:extLst>
                    <a:ext uri="{FF2B5EF4-FFF2-40B4-BE49-F238E27FC236}">
                      <a16:creationId xmlns:a16="http://schemas.microsoft.com/office/drawing/2014/main" id="{F0842EBE-900F-4391-AC0C-74D697E0B3F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507" y="2267"/>
                  <a:ext cx="7" cy="19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69" name="Line 106">
                  <a:extLst>
                    <a:ext uri="{FF2B5EF4-FFF2-40B4-BE49-F238E27FC236}">
                      <a16:creationId xmlns:a16="http://schemas.microsoft.com/office/drawing/2014/main" id="{1B432CCD-CDBD-4CFC-BFC5-246FB0FD39C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522" y="2309"/>
                  <a:ext cx="8" cy="19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70" name="Line 107">
                  <a:extLst>
                    <a:ext uri="{FF2B5EF4-FFF2-40B4-BE49-F238E27FC236}">
                      <a16:creationId xmlns:a16="http://schemas.microsoft.com/office/drawing/2014/main" id="{562F716E-5710-41A9-B715-DDA1EA37B73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538" y="2351"/>
                  <a:ext cx="7" cy="19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71" name="Line 108">
                  <a:extLst>
                    <a:ext uri="{FF2B5EF4-FFF2-40B4-BE49-F238E27FC236}">
                      <a16:creationId xmlns:a16="http://schemas.microsoft.com/office/drawing/2014/main" id="{732B6122-5CFF-4173-8978-FB3181EE99D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553" y="2393"/>
                  <a:ext cx="7" cy="19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72" name="Line 109">
                  <a:extLst>
                    <a:ext uri="{FF2B5EF4-FFF2-40B4-BE49-F238E27FC236}">
                      <a16:creationId xmlns:a16="http://schemas.microsoft.com/office/drawing/2014/main" id="{F0380372-CC67-46ED-A27C-35D71D311F9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568" y="2435"/>
                  <a:ext cx="7" cy="19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73" name="Line 110">
                  <a:extLst>
                    <a:ext uri="{FF2B5EF4-FFF2-40B4-BE49-F238E27FC236}">
                      <a16:creationId xmlns:a16="http://schemas.microsoft.com/office/drawing/2014/main" id="{FED72333-C8DF-4EC6-92B8-C0D79CADF08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584" y="2477"/>
                  <a:ext cx="7" cy="19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74" name="Line 111">
                  <a:extLst>
                    <a:ext uri="{FF2B5EF4-FFF2-40B4-BE49-F238E27FC236}">
                      <a16:creationId xmlns:a16="http://schemas.microsoft.com/office/drawing/2014/main" id="{5D166531-D461-4488-B525-B7AD0519463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599" y="2519"/>
                  <a:ext cx="7" cy="19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75" name="Line 112">
                  <a:extLst>
                    <a:ext uri="{FF2B5EF4-FFF2-40B4-BE49-F238E27FC236}">
                      <a16:creationId xmlns:a16="http://schemas.microsoft.com/office/drawing/2014/main" id="{9F4311E5-B637-49DB-9ADD-BABC1EAAAF4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614" y="2561"/>
                  <a:ext cx="8" cy="19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76" name="Line 113">
                  <a:extLst>
                    <a:ext uri="{FF2B5EF4-FFF2-40B4-BE49-F238E27FC236}">
                      <a16:creationId xmlns:a16="http://schemas.microsoft.com/office/drawing/2014/main" id="{8E0D4016-07AF-46A6-8564-31D3C4497BE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629" y="2603"/>
                  <a:ext cx="8" cy="19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77" name="Line 114">
                  <a:extLst>
                    <a:ext uri="{FF2B5EF4-FFF2-40B4-BE49-F238E27FC236}">
                      <a16:creationId xmlns:a16="http://schemas.microsoft.com/office/drawing/2014/main" id="{BF67EEF2-A882-472D-9F20-36A320AB511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645" y="2645"/>
                  <a:ext cx="7" cy="19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78" name="Line 115">
                  <a:extLst>
                    <a:ext uri="{FF2B5EF4-FFF2-40B4-BE49-F238E27FC236}">
                      <a16:creationId xmlns:a16="http://schemas.microsoft.com/office/drawing/2014/main" id="{7ECE40E5-B046-4AAD-8012-93E9E178CF2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660" y="2686"/>
                  <a:ext cx="7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79" name="Line 116">
                  <a:extLst>
                    <a:ext uri="{FF2B5EF4-FFF2-40B4-BE49-F238E27FC236}">
                      <a16:creationId xmlns:a16="http://schemas.microsoft.com/office/drawing/2014/main" id="{643E6F27-9C81-4F03-B864-8C1C6D45EAE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676" y="2728"/>
                  <a:ext cx="6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80" name="Line 117">
                  <a:extLst>
                    <a:ext uri="{FF2B5EF4-FFF2-40B4-BE49-F238E27FC236}">
                      <a16:creationId xmlns:a16="http://schemas.microsoft.com/office/drawing/2014/main" id="{DE8B855A-451D-45A3-951D-BB43CE7AD85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691" y="2770"/>
                  <a:ext cx="7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81" name="Line 118">
                  <a:extLst>
                    <a:ext uri="{FF2B5EF4-FFF2-40B4-BE49-F238E27FC236}">
                      <a16:creationId xmlns:a16="http://schemas.microsoft.com/office/drawing/2014/main" id="{D49B69F1-FEBA-4C40-BAD6-CFF099AB8C1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706" y="2812"/>
                  <a:ext cx="7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82" name="Line 119">
                  <a:extLst>
                    <a:ext uri="{FF2B5EF4-FFF2-40B4-BE49-F238E27FC236}">
                      <a16:creationId xmlns:a16="http://schemas.microsoft.com/office/drawing/2014/main" id="{A3734416-640E-47DC-8437-8C9DC6513EB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721" y="2854"/>
                  <a:ext cx="8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83" name="Line 120">
                  <a:extLst>
                    <a:ext uri="{FF2B5EF4-FFF2-40B4-BE49-F238E27FC236}">
                      <a16:creationId xmlns:a16="http://schemas.microsoft.com/office/drawing/2014/main" id="{4AEF8E39-31F6-4D22-B228-F7FD7D5A1EB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737" y="2896"/>
                  <a:ext cx="7" cy="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84" name="Line 121">
                  <a:extLst>
                    <a:ext uri="{FF2B5EF4-FFF2-40B4-BE49-F238E27FC236}">
                      <a16:creationId xmlns:a16="http://schemas.microsoft.com/office/drawing/2014/main" id="{3884C968-F4D5-4C66-9CC5-275828FA1DF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752" y="2938"/>
                  <a:ext cx="5" cy="12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85" name="Line 122">
                  <a:extLst>
                    <a:ext uri="{FF2B5EF4-FFF2-40B4-BE49-F238E27FC236}">
                      <a16:creationId xmlns:a16="http://schemas.microsoft.com/office/drawing/2014/main" id="{277DEB36-4A46-453B-A59B-B76CD3F516F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 flipV="1">
                  <a:off x="4752" y="2938"/>
                  <a:ext cx="5" cy="12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86" name="Rectangle 123">
                  <a:extLst>
                    <a:ext uri="{FF2B5EF4-FFF2-40B4-BE49-F238E27FC236}">
                      <a16:creationId xmlns:a16="http://schemas.microsoft.com/office/drawing/2014/main" id="{AAB6B757-7202-4E2E-996C-98B214F3722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21" y="1890"/>
                  <a:ext cx="33" cy="33"/>
                </a:xfrm>
                <a:prstGeom prst="rect">
                  <a:avLst/>
                </a:prstGeom>
                <a:solidFill>
                  <a:srgbClr val="000000"/>
                </a:solidFill>
                <a:ln w="4763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87" name="Rectangle 124">
                  <a:extLst>
                    <a:ext uri="{FF2B5EF4-FFF2-40B4-BE49-F238E27FC236}">
                      <a16:creationId xmlns:a16="http://schemas.microsoft.com/office/drawing/2014/main" id="{27B4DE8F-A7C6-4703-B490-9F5B4E2FB74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97" y="2921"/>
                  <a:ext cx="33" cy="33"/>
                </a:xfrm>
                <a:prstGeom prst="rect">
                  <a:avLst/>
                </a:prstGeom>
                <a:solidFill>
                  <a:srgbClr val="000000"/>
                </a:solidFill>
                <a:ln w="4763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88" name="Rectangle 125">
                  <a:extLst>
                    <a:ext uri="{FF2B5EF4-FFF2-40B4-BE49-F238E27FC236}">
                      <a16:creationId xmlns:a16="http://schemas.microsoft.com/office/drawing/2014/main" id="{C82AC590-68EF-4D95-BB14-75C366FD0E0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174" y="1384"/>
                  <a:ext cx="33" cy="33"/>
                </a:xfrm>
                <a:prstGeom prst="rect">
                  <a:avLst/>
                </a:prstGeom>
                <a:solidFill>
                  <a:srgbClr val="000000"/>
                </a:solidFill>
                <a:ln w="4763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89" name="Rectangle 126">
                  <a:extLst>
                    <a:ext uri="{FF2B5EF4-FFF2-40B4-BE49-F238E27FC236}">
                      <a16:creationId xmlns:a16="http://schemas.microsoft.com/office/drawing/2014/main" id="{335B60AD-2881-4251-842F-A540C41DB69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21" y="1890"/>
                  <a:ext cx="33" cy="33"/>
                </a:xfrm>
                <a:prstGeom prst="rect">
                  <a:avLst/>
                </a:prstGeom>
                <a:solidFill>
                  <a:srgbClr val="000000"/>
                </a:solidFill>
                <a:ln w="4763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90" name="Rectangle 127">
                  <a:extLst>
                    <a:ext uri="{FF2B5EF4-FFF2-40B4-BE49-F238E27FC236}">
                      <a16:creationId xmlns:a16="http://schemas.microsoft.com/office/drawing/2014/main" id="{376608B8-EB68-474E-A57F-C408E9BC919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97" y="2921"/>
                  <a:ext cx="33" cy="33"/>
                </a:xfrm>
                <a:prstGeom prst="rect">
                  <a:avLst/>
                </a:prstGeom>
                <a:solidFill>
                  <a:srgbClr val="000000"/>
                </a:solidFill>
                <a:ln w="4763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91" name="Rectangle 128">
                  <a:extLst>
                    <a:ext uri="{FF2B5EF4-FFF2-40B4-BE49-F238E27FC236}">
                      <a16:creationId xmlns:a16="http://schemas.microsoft.com/office/drawing/2014/main" id="{5F374162-55BF-453C-A090-5C17F9BC25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174" y="1384"/>
                  <a:ext cx="33" cy="33"/>
                </a:xfrm>
                <a:prstGeom prst="rect">
                  <a:avLst/>
                </a:prstGeom>
                <a:solidFill>
                  <a:srgbClr val="000000"/>
                </a:solidFill>
                <a:ln w="4763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92" name="Rectangle 129">
                  <a:extLst>
                    <a:ext uri="{FF2B5EF4-FFF2-40B4-BE49-F238E27FC236}">
                      <a16:creationId xmlns:a16="http://schemas.microsoft.com/office/drawing/2014/main" id="{76674223-C46A-4911-9EEC-7D60A9AB391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750" y="2960"/>
                  <a:ext cx="33" cy="33"/>
                </a:xfrm>
                <a:prstGeom prst="rect">
                  <a:avLst/>
                </a:prstGeom>
                <a:solidFill>
                  <a:srgbClr val="000000"/>
                </a:solidFill>
                <a:ln w="4763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93" name="Line 130">
                  <a:extLst>
                    <a:ext uri="{FF2B5EF4-FFF2-40B4-BE49-F238E27FC236}">
                      <a16:creationId xmlns:a16="http://schemas.microsoft.com/office/drawing/2014/main" id="{21105731-6FC2-4048-8D32-1A2B61BF808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750" y="3021"/>
                  <a:ext cx="2304" cy="0"/>
                </a:xfrm>
                <a:prstGeom prst="line">
                  <a:avLst/>
                </a:prstGeom>
                <a:noFill/>
                <a:ln w="11113" cap="sq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94" name="Line 131">
                  <a:extLst>
                    <a:ext uri="{FF2B5EF4-FFF2-40B4-BE49-F238E27FC236}">
                      <a16:creationId xmlns:a16="http://schemas.microsoft.com/office/drawing/2014/main" id="{D4D5FE1A-3E4C-41D6-949F-AE077D1BB9C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750" y="3021"/>
                  <a:ext cx="2304" cy="0"/>
                </a:xfrm>
                <a:prstGeom prst="line">
                  <a:avLst/>
                </a:prstGeom>
                <a:noFill/>
                <a:ln w="11113" cap="sq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95" name="Line 132">
                  <a:extLst>
                    <a:ext uri="{FF2B5EF4-FFF2-40B4-BE49-F238E27FC236}">
                      <a16:creationId xmlns:a16="http://schemas.microsoft.com/office/drawing/2014/main" id="{D4354F87-8834-4169-BA70-44A67AA28F4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750" y="3021"/>
                  <a:ext cx="0" cy="18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96" name="Line 133">
                  <a:extLst>
                    <a:ext uri="{FF2B5EF4-FFF2-40B4-BE49-F238E27FC236}">
                      <a16:creationId xmlns:a16="http://schemas.microsoft.com/office/drawing/2014/main" id="{22574B74-2CA6-48B9-9798-876A58E60B8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326" y="3021"/>
                  <a:ext cx="0" cy="18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97" name="Line 134">
                  <a:extLst>
                    <a:ext uri="{FF2B5EF4-FFF2-40B4-BE49-F238E27FC236}">
                      <a16:creationId xmlns:a16="http://schemas.microsoft.com/office/drawing/2014/main" id="{C9466401-10AF-4D4D-B6B1-59D804ABE6B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902" y="3021"/>
                  <a:ext cx="0" cy="18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98" name="Line 135">
                  <a:extLst>
                    <a:ext uri="{FF2B5EF4-FFF2-40B4-BE49-F238E27FC236}">
                      <a16:creationId xmlns:a16="http://schemas.microsoft.com/office/drawing/2014/main" id="{2A4B95DC-FD12-422A-B40A-D7DA4057BF5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478" y="3021"/>
                  <a:ext cx="0" cy="18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99" name="Line 136">
                  <a:extLst>
                    <a:ext uri="{FF2B5EF4-FFF2-40B4-BE49-F238E27FC236}">
                      <a16:creationId xmlns:a16="http://schemas.microsoft.com/office/drawing/2014/main" id="{4D0EADF8-6187-4599-B3DD-A9BEBE6DC5A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054" y="3021"/>
                  <a:ext cx="0" cy="18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100" name="Line 137">
                  <a:extLst>
                    <a:ext uri="{FF2B5EF4-FFF2-40B4-BE49-F238E27FC236}">
                      <a16:creationId xmlns:a16="http://schemas.microsoft.com/office/drawing/2014/main" id="{1C73D6FF-E0EF-43E3-A063-EC9532D67E2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038" y="3021"/>
                  <a:ext cx="0" cy="36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101" name="Line 138">
                  <a:extLst>
                    <a:ext uri="{FF2B5EF4-FFF2-40B4-BE49-F238E27FC236}">
                      <a16:creationId xmlns:a16="http://schemas.microsoft.com/office/drawing/2014/main" id="{C9239936-980C-43A4-9B3B-03A421B8D40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614" y="3021"/>
                  <a:ext cx="0" cy="36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102" name="Line 139">
                  <a:extLst>
                    <a:ext uri="{FF2B5EF4-FFF2-40B4-BE49-F238E27FC236}">
                      <a16:creationId xmlns:a16="http://schemas.microsoft.com/office/drawing/2014/main" id="{8D6D74C5-0DF1-4AB5-A1FA-6F3DF672899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190" y="3021"/>
                  <a:ext cx="0" cy="36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103" name="Line 140">
                  <a:extLst>
                    <a:ext uri="{FF2B5EF4-FFF2-40B4-BE49-F238E27FC236}">
                      <a16:creationId xmlns:a16="http://schemas.microsoft.com/office/drawing/2014/main" id="{DFE4876E-6F60-40DC-B11C-8401A5B66B0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767" y="3021"/>
                  <a:ext cx="0" cy="36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104" name="Line 141">
                  <a:extLst>
                    <a:ext uri="{FF2B5EF4-FFF2-40B4-BE49-F238E27FC236}">
                      <a16:creationId xmlns:a16="http://schemas.microsoft.com/office/drawing/2014/main" id="{08D7BABD-5574-41E5-8E43-DAD7B022A9D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750" y="1164"/>
                  <a:ext cx="0" cy="1857"/>
                </a:xfrm>
                <a:prstGeom prst="line">
                  <a:avLst/>
                </a:prstGeom>
                <a:noFill/>
                <a:ln w="11113" cap="sq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105" name="Line 142">
                  <a:extLst>
                    <a:ext uri="{FF2B5EF4-FFF2-40B4-BE49-F238E27FC236}">
                      <a16:creationId xmlns:a16="http://schemas.microsoft.com/office/drawing/2014/main" id="{9108776F-9A76-47A5-AA84-E22FC16426D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2732" y="2852"/>
                  <a:ext cx="18" cy="0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106" name="Line 143">
                  <a:extLst>
                    <a:ext uri="{FF2B5EF4-FFF2-40B4-BE49-F238E27FC236}">
                      <a16:creationId xmlns:a16="http://schemas.microsoft.com/office/drawing/2014/main" id="{5C46528B-B798-409E-9574-5F57AA68728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2732" y="2515"/>
                  <a:ext cx="18" cy="0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107" name="Line 144">
                  <a:extLst>
                    <a:ext uri="{FF2B5EF4-FFF2-40B4-BE49-F238E27FC236}">
                      <a16:creationId xmlns:a16="http://schemas.microsoft.com/office/drawing/2014/main" id="{7560FE49-9C82-4101-8F8B-A1416151EE2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2732" y="2177"/>
                  <a:ext cx="18" cy="0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108" name="Line 145">
                  <a:extLst>
                    <a:ext uri="{FF2B5EF4-FFF2-40B4-BE49-F238E27FC236}">
                      <a16:creationId xmlns:a16="http://schemas.microsoft.com/office/drawing/2014/main" id="{F0F184D5-20E9-49FD-A50B-6F43FAABBF8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2732" y="1840"/>
                  <a:ext cx="18" cy="0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109" name="Line 146">
                  <a:extLst>
                    <a:ext uri="{FF2B5EF4-FFF2-40B4-BE49-F238E27FC236}">
                      <a16:creationId xmlns:a16="http://schemas.microsoft.com/office/drawing/2014/main" id="{0501E3B1-B136-4C14-A19F-6F31D1E0505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2732" y="1502"/>
                  <a:ext cx="18" cy="0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110" name="Line 147">
                  <a:extLst>
                    <a:ext uri="{FF2B5EF4-FFF2-40B4-BE49-F238E27FC236}">
                      <a16:creationId xmlns:a16="http://schemas.microsoft.com/office/drawing/2014/main" id="{B0BA7660-AD06-4D98-B3FA-5C72B213CBB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2732" y="1164"/>
                  <a:ext cx="18" cy="0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111" name="Line 148">
                  <a:extLst>
                    <a:ext uri="{FF2B5EF4-FFF2-40B4-BE49-F238E27FC236}">
                      <a16:creationId xmlns:a16="http://schemas.microsoft.com/office/drawing/2014/main" id="{D0516C7D-71FE-4B3E-971F-48B9EAAE373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2714" y="3021"/>
                  <a:ext cx="36" cy="0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112" name="Line 149">
                  <a:extLst>
                    <a:ext uri="{FF2B5EF4-FFF2-40B4-BE49-F238E27FC236}">
                      <a16:creationId xmlns:a16="http://schemas.microsoft.com/office/drawing/2014/main" id="{671B7C6E-6061-479E-9611-A62F2BC7EBF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2714" y="2683"/>
                  <a:ext cx="36" cy="0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113" name="Line 150">
                  <a:extLst>
                    <a:ext uri="{FF2B5EF4-FFF2-40B4-BE49-F238E27FC236}">
                      <a16:creationId xmlns:a16="http://schemas.microsoft.com/office/drawing/2014/main" id="{0E539090-1942-4E10-BE40-A485DA5DDDC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2714" y="2346"/>
                  <a:ext cx="36" cy="0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114" name="Line 151">
                  <a:extLst>
                    <a:ext uri="{FF2B5EF4-FFF2-40B4-BE49-F238E27FC236}">
                      <a16:creationId xmlns:a16="http://schemas.microsoft.com/office/drawing/2014/main" id="{FAFC0B24-934F-43E5-81C2-BD93029C6DC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2714" y="2008"/>
                  <a:ext cx="36" cy="0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115" name="Line 152">
                  <a:extLst>
                    <a:ext uri="{FF2B5EF4-FFF2-40B4-BE49-F238E27FC236}">
                      <a16:creationId xmlns:a16="http://schemas.microsoft.com/office/drawing/2014/main" id="{F8137F73-1D17-47F4-B7E4-BE5BBF4B867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2714" y="1671"/>
                  <a:ext cx="36" cy="0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116" name="Line 153">
                  <a:extLst>
                    <a:ext uri="{FF2B5EF4-FFF2-40B4-BE49-F238E27FC236}">
                      <a16:creationId xmlns:a16="http://schemas.microsoft.com/office/drawing/2014/main" id="{562FCAB9-0B14-48A1-9116-E13E42F3F99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2714" y="1333"/>
                  <a:ext cx="36" cy="0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117" name="Rectangle 154">
                  <a:extLst>
                    <a:ext uri="{FF2B5EF4-FFF2-40B4-BE49-F238E27FC236}">
                      <a16:creationId xmlns:a16="http://schemas.microsoft.com/office/drawing/2014/main" id="{378E2402-72EE-48F0-918E-000AE3E1AF5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955" y="3071"/>
                  <a:ext cx="201" cy="10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</a:rPr>
                    <a:t>CNN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118" name="Rectangle 155">
                  <a:extLst>
                    <a:ext uri="{FF2B5EF4-FFF2-40B4-BE49-F238E27FC236}">
                      <a16:creationId xmlns:a16="http://schemas.microsoft.com/office/drawing/2014/main" id="{4158F6CB-2EB6-4684-AB47-34A8DBE3515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51" y="3071"/>
                  <a:ext cx="161" cy="10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</a:rPr>
                    <a:t>AM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119" name="Rectangle 156">
                  <a:extLst>
                    <a:ext uri="{FF2B5EF4-FFF2-40B4-BE49-F238E27FC236}">
                      <a16:creationId xmlns:a16="http://schemas.microsoft.com/office/drawing/2014/main" id="{351632F4-E4A5-4F35-8EFC-114978E15A7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140" y="3071"/>
                  <a:ext cx="134" cy="10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</a:rPr>
                    <a:t>SA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120" name="Rectangle 157">
                  <a:extLst>
                    <a:ext uri="{FF2B5EF4-FFF2-40B4-BE49-F238E27FC236}">
                      <a16:creationId xmlns:a16="http://schemas.microsoft.com/office/drawing/2014/main" id="{81DE2D57-DA78-4822-8922-DCF291B3BB0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436" y="3071"/>
                  <a:ext cx="700" cy="10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</a:rPr>
                    <a:t>The improved model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121" name="Rectangle 158">
                  <a:extLst>
                    <a:ext uri="{FF2B5EF4-FFF2-40B4-BE49-F238E27FC236}">
                      <a16:creationId xmlns:a16="http://schemas.microsoft.com/office/drawing/2014/main" id="{0C2C1CB2-3A65-4089-BAEB-1729B096E2E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11" y="2973"/>
                  <a:ext cx="212" cy="10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</a:rPr>
                    <a:t>0.000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122" name="Rectangle 159">
                  <a:extLst>
                    <a:ext uri="{FF2B5EF4-FFF2-40B4-BE49-F238E27FC236}">
                      <a16:creationId xmlns:a16="http://schemas.microsoft.com/office/drawing/2014/main" id="{4B390169-C840-4FD8-9B39-322783DE457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11" y="2635"/>
                  <a:ext cx="212" cy="10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</a:rPr>
                    <a:t>0.002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123" name="Rectangle 160">
                  <a:extLst>
                    <a:ext uri="{FF2B5EF4-FFF2-40B4-BE49-F238E27FC236}">
                      <a16:creationId xmlns:a16="http://schemas.microsoft.com/office/drawing/2014/main" id="{037972F5-62A6-46FF-BDCA-9396599731C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11" y="2297"/>
                  <a:ext cx="212" cy="10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</a:rPr>
                    <a:t>0.004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124" name="Rectangle 161">
                  <a:extLst>
                    <a:ext uri="{FF2B5EF4-FFF2-40B4-BE49-F238E27FC236}">
                      <a16:creationId xmlns:a16="http://schemas.microsoft.com/office/drawing/2014/main" id="{A38BF6A0-5865-4F96-BC67-4F0E1CC6193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11" y="1960"/>
                  <a:ext cx="212" cy="10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</a:rPr>
                    <a:t>0.006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125" name="Rectangle 162">
                  <a:extLst>
                    <a:ext uri="{FF2B5EF4-FFF2-40B4-BE49-F238E27FC236}">
                      <a16:creationId xmlns:a16="http://schemas.microsoft.com/office/drawing/2014/main" id="{AB1422E0-8556-4E45-B90B-19ACD80A888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11" y="1622"/>
                  <a:ext cx="212" cy="10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</a:rPr>
                    <a:t>0.008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126" name="Rectangle 163">
                  <a:extLst>
                    <a:ext uri="{FF2B5EF4-FFF2-40B4-BE49-F238E27FC236}">
                      <a16:creationId xmlns:a16="http://schemas.microsoft.com/office/drawing/2014/main" id="{75E3D0C1-78D7-429D-B9EB-4D56618C67C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11" y="1285"/>
                  <a:ext cx="212" cy="10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</a:rPr>
                    <a:t>0.010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127" name="Rectangle 164">
                  <a:extLst>
                    <a:ext uri="{FF2B5EF4-FFF2-40B4-BE49-F238E27FC236}">
                      <a16:creationId xmlns:a16="http://schemas.microsoft.com/office/drawing/2014/main" id="{CF2E07CF-ACED-4658-89EF-221F80FE343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2335" y="1992"/>
                  <a:ext cx="237" cy="14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</a:rPr>
                    <a:t>Loss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128" name="Rectangle 165">
                  <a:extLst>
                    <a:ext uri="{FF2B5EF4-FFF2-40B4-BE49-F238E27FC236}">
                      <a16:creationId xmlns:a16="http://schemas.microsoft.com/office/drawing/2014/main" id="{8EAC9906-7F26-40B0-B40E-D9AB6207200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680" y="3207"/>
                  <a:ext cx="482" cy="12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</a:rPr>
                    <a:t>Model </a:t>
                  </a:r>
                  <a:r>
                    <a:rPr kumimoji="0" lang="zh-CN" altLang="zh-CN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</a:rPr>
                    <a:t>type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129" name="Rectangle 166">
                  <a:extLst>
                    <a:ext uri="{FF2B5EF4-FFF2-40B4-BE49-F238E27FC236}">
                      <a16:creationId xmlns:a16="http://schemas.microsoft.com/office/drawing/2014/main" id="{7B97E6AE-0099-4453-8A0D-D9645578B33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71" y="1081"/>
                  <a:ext cx="1211" cy="370"/>
                </a:xfrm>
                <a:prstGeom prst="rect">
                  <a:avLst/>
                </a:prstGeom>
                <a:solidFill>
                  <a:srgbClr val="FFFFFF"/>
                </a:solidFill>
                <a:ln w="317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130" name="Rectangle 167">
                  <a:extLst>
                    <a:ext uri="{FF2B5EF4-FFF2-40B4-BE49-F238E27FC236}">
                      <a16:creationId xmlns:a16="http://schemas.microsoft.com/office/drawing/2014/main" id="{58A6EDA4-6BC0-47FE-9A98-817BB32A584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86" y="1096"/>
                  <a:ext cx="212" cy="104"/>
                </a:xfrm>
                <a:prstGeom prst="rect">
                  <a:avLst/>
                </a:prstGeom>
                <a:solidFill>
                  <a:srgbClr val="00FF00"/>
                </a:solidFill>
                <a:ln w="63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pic>
              <p:nvPicPr>
                <p:cNvPr id="1192" name="Picture 168">
                  <a:extLst>
                    <a:ext uri="{FF2B5EF4-FFF2-40B4-BE49-F238E27FC236}">
                      <a16:creationId xmlns:a16="http://schemas.microsoft.com/office/drawing/2014/main" id="{1343FA8B-ED09-4EA3-84C1-2F2A9C041D31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10" cstate="hq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886" y="1096"/>
                  <a:ext cx="212" cy="10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1193" name="Picture 169">
                  <a:extLst>
                    <a:ext uri="{FF2B5EF4-FFF2-40B4-BE49-F238E27FC236}">
                      <a16:creationId xmlns:a16="http://schemas.microsoft.com/office/drawing/2014/main" id="{47CA8B94-3B8E-4138-B1B3-74B03FF14871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11" cstate="hq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886" y="1096"/>
                  <a:ext cx="212" cy="10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1131" name="Rectangle 170">
                  <a:extLst>
                    <a:ext uri="{FF2B5EF4-FFF2-40B4-BE49-F238E27FC236}">
                      <a16:creationId xmlns:a16="http://schemas.microsoft.com/office/drawing/2014/main" id="{0AAED4A5-6259-46F1-8865-201BC544F65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86" y="1096"/>
                  <a:ext cx="212" cy="104"/>
                </a:xfrm>
                <a:prstGeom prst="rect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132" name="Rectangle 171">
                  <a:extLst>
                    <a:ext uri="{FF2B5EF4-FFF2-40B4-BE49-F238E27FC236}">
                      <a16:creationId xmlns:a16="http://schemas.microsoft.com/office/drawing/2014/main" id="{A2840925-712F-4309-AFDE-E2DAFE856DE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00" y="1093"/>
                  <a:ext cx="834" cy="14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</a:rPr>
                    <a:t> Good visual effect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133" name="Rectangle 172">
                  <a:extLst>
                    <a:ext uri="{FF2B5EF4-FFF2-40B4-BE49-F238E27FC236}">
                      <a16:creationId xmlns:a16="http://schemas.microsoft.com/office/drawing/2014/main" id="{5EF12856-A3E6-447D-A913-17F62A943DD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85" y="1212"/>
                  <a:ext cx="1205" cy="14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</a:rPr>
                    <a:t>          General visual effects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134" name="Rectangle 173">
                  <a:extLst>
                    <a:ext uri="{FF2B5EF4-FFF2-40B4-BE49-F238E27FC236}">
                      <a16:creationId xmlns:a16="http://schemas.microsoft.com/office/drawing/2014/main" id="{A4362FB4-A0F6-4D9B-A4EE-7C5D8F1E9E8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885" y="1330"/>
                  <a:ext cx="1034" cy="14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</a:rPr>
                    <a:t>          Poor visual effect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</p:grpSp>
          <p:pic>
            <p:nvPicPr>
              <p:cNvPr id="1136" name="图片 1135">
                <a:extLst>
                  <a:ext uri="{FF2B5EF4-FFF2-40B4-BE49-F238E27FC236}">
                    <a16:creationId xmlns:a16="http://schemas.microsoft.com/office/drawing/2014/main" id="{E011F4EB-1D0E-4036-A384-86D7D4ECF8D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4580659" y="1934441"/>
                <a:ext cx="340425" cy="148936"/>
              </a:xfrm>
              <a:prstGeom prst="rect">
                <a:avLst/>
              </a:prstGeom>
            </p:spPr>
          </p:pic>
          <p:pic>
            <p:nvPicPr>
              <p:cNvPr id="1138" name="图片 1137">
                <a:extLst>
                  <a:ext uri="{FF2B5EF4-FFF2-40B4-BE49-F238E27FC236}">
                    <a16:creationId xmlns:a16="http://schemas.microsoft.com/office/drawing/2014/main" id="{51DB7026-56AB-48C9-A508-135D3EAC6DB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4589751" y="2112386"/>
                <a:ext cx="321183" cy="163224"/>
              </a:xfrm>
              <a:prstGeom prst="rect">
                <a:avLst/>
              </a:prstGeom>
            </p:spPr>
          </p:pic>
        </p:grpSp>
        <p:sp>
          <p:nvSpPr>
            <p:cNvPr id="2" name="文本框 1"/>
            <p:cNvSpPr txBox="1"/>
            <p:nvPr/>
          </p:nvSpPr>
          <p:spPr>
            <a:xfrm>
              <a:off x="4383336" y="2936206"/>
              <a:ext cx="67839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065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6" name="文本框 175"/>
            <p:cNvSpPr txBox="1"/>
            <p:nvPr/>
          </p:nvSpPr>
          <p:spPr>
            <a:xfrm>
              <a:off x="5278177" y="4426924"/>
              <a:ext cx="67839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005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7" name="文本框 176"/>
            <p:cNvSpPr txBox="1"/>
            <p:nvPr/>
          </p:nvSpPr>
          <p:spPr>
            <a:xfrm>
              <a:off x="6240980" y="2187339"/>
              <a:ext cx="67839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095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8" name="文本框 177"/>
            <p:cNvSpPr txBox="1"/>
            <p:nvPr/>
          </p:nvSpPr>
          <p:spPr>
            <a:xfrm>
              <a:off x="7076268" y="4439890"/>
              <a:ext cx="67839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002</a:t>
              </a:r>
              <a:endPara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0631002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43</Words>
  <Application>Microsoft Office PowerPoint</Application>
  <PresentationFormat>宽屏</PresentationFormat>
  <Paragraphs>1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Think</dc:creator>
  <cp:lastModifiedBy>China</cp:lastModifiedBy>
  <cp:revision>4</cp:revision>
  <dcterms:created xsi:type="dcterms:W3CDTF">2022-06-29T05:01:22Z</dcterms:created>
  <dcterms:modified xsi:type="dcterms:W3CDTF">2023-03-09T03:02:20Z</dcterms:modified>
</cp:coreProperties>
</file>